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20" r:id="rId1"/>
  </p:sldMasterIdLst>
  <p:notesMasterIdLst>
    <p:notesMasterId r:id="rId5"/>
  </p:notesMasterIdLst>
  <p:sldIdLst>
    <p:sldId id="352" r:id="rId2"/>
    <p:sldId id="261" r:id="rId3"/>
    <p:sldId id="289" r:id="rId4"/>
  </p:sldIdLst>
  <p:sldSz cx="9601200" cy="12801600" type="A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5714"/>
  </p:normalViewPr>
  <p:slideViewPr>
    <p:cSldViewPr snapToGrid="0" snapToObjects="1">
      <p:cViewPr varScale="1">
        <p:scale>
          <a:sx n="65" d="100"/>
          <a:sy n="65" d="100"/>
        </p:scale>
        <p:origin x="3456" y="2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106E4AD-7C0D-B34C-91F4-8A3A2D84C000}" type="datetimeFigureOut">
              <a:rPr lang="en-US" smtClean="0"/>
              <a:t>2/21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52A1B1F-2791-DC46-8120-6DF9DE274F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75305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380895" rtl="0" eaLnBrk="1" latinLnBrk="0" hangingPunct="1">
      <a:defRPr sz="1813" kern="1200">
        <a:solidFill>
          <a:schemeClr val="tx1"/>
        </a:solidFill>
        <a:latin typeface="+mn-lt"/>
        <a:ea typeface="+mn-ea"/>
        <a:cs typeface="+mn-cs"/>
      </a:defRPr>
    </a:lvl1pPr>
    <a:lvl2pPr marL="690446" algn="l" defTabSz="1380895" rtl="0" eaLnBrk="1" latinLnBrk="0" hangingPunct="1">
      <a:defRPr sz="1813" kern="1200">
        <a:solidFill>
          <a:schemeClr val="tx1"/>
        </a:solidFill>
        <a:latin typeface="+mn-lt"/>
        <a:ea typeface="+mn-ea"/>
        <a:cs typeface="+mn-cs"/>
      </a:defRPr>
    </a:lvl2pPr>
    <a:lvl3pPr marL="1380895" algn="l" defTabSz="1380895" rtl="0" eaLnBrk="1" latinLnBrk="0" hangingPunct="1">
      <a:defRPr sz="1813" kern="1200">
        <a:solidFill>
          <a:schemeClr val="tx1"/>
        </a:solidFill>
        <a:latin typeface="+mn-lt"/>
        <a:ea typeface="+mn-ea"/>
        <a:cs typeface="+mn-cs"/>
      </a:defRPr>
    </a:lvl3pPr>
    <a:lvl4pPr marL="2071341" algn="l" defTabSz="1380895" rtl="0" eaLnBrk="1" latinLnBrk="0" hangingPunct="1">
      <a:defRPr sz="1813" kern="1200">
        <a:solidFill>
          <a:schemeClr val="tx1"/>
        </a:solidFill>
        <a:latin typeface="+mn-lt"/>
        <a:ea typeface="+mn-ea"/>
        <a:cs typeface="+mn-cs"/>
      </a:defRPr>
    </a:lvl4pPr>
    <a:lvl5pPr marL="2761789" algn="l" defTabSz="1380895" rtl="0" eaLnBrk="1" latinLnBrk="0" hangingPunct="1">
      <a:defRPr sz="1813" kern="1200">
        <a:solidFill>
          <a:schemeClr val="tx1"/>
        </a:solidFill>
        <a:latin typeface="+mn-lt"/>
        <a:ea typeface="+mn-ea"/>
        <a:cs typeface="+mn-cs"/>
      </a:defRPr>
    </a:lvl5pPr>
    <a:lvl6pPr marL="3452236" algn="l" defTabSz="1380895" rtl="0" eaLnBrk="1" latinLnBrk="0" hangingPunct="1">
      <a:defRPr sz="1813" kern="1200">
        <a:solidFill>
          <a:schemeClr val="tx1"/>
        </a:solidFill>
        <a:latin typeface="+mn-lt"/>
        <a:ea typeface="+mn-ea"/>
        <a:cs typeface="+mn-cs"/>
      </a:defRPr>
    </a:lvl6pPr>
    <a:lvl7pPr marL="4142684" algn="l" defTabSz="1380895" rtl="0" eaLnBrk="1" latinLnBrk="0" hangingPunct="1">
      <a:defRPr sz="1813" kern="1200">
        <a:solidFill>
          <a:schemeClr val="tx1"/>
        </a:solidFill>
        <a:latin typeface="+mn-lt"/>
        <a:ea typeface="+mn-ea"/>
        <a:cs typeface="+mn-cs"/>
      </a:defRPr>
    </a:lvl7pPr>
    <a:lvl8pPr marL="4833131" algn="l" defTabSz="1380895" rtl="0" eaLnBrk="1" latinLnBrk="0" hangingPunct="1">
      <a:defRPr sz="1813" kern="1200">
        <a:solidFill>
          <a:schemeClr val="tx1"/>
        </a:solidFill>
        <a:latin typeface="+mn-lt"/>
        <a:ea typeface="+mn-ea"/>
        <a:cs typeface="+mn-cs"/>
      </a:defRPr>
    </a:lvl8pPr>
    <a:lvl9pPr marL="5523577" algn="l" defTabSz="1380895" rtl="0" eaLnBrk="1" latinLnBrk="0" hangingPunct="1">
      <a:defRPr sz="1813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Lo </a:t>
            </a:r>
            <a:r>
              <a:rPr lang="en-US" dirty="0" err="1"/>
              <a:t>mismo</a:t>
            </a:r>
            <a:r>
              <a:rPr lang="en-US" dirty="0"/>
              <a:t> para BSA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BAA67BB-BEDB-4AE7-B6D7-5D384AE637B4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78863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A4233-F2BF-1247-B12B-A152D7403BAA}" type="datetimeFigureOut">
              <a:rPr lang="en-US" smtClean="0"/>
              <a:t>2/2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80D4A-827A-4641-B335-57EB1696B1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07081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A4233-F2BF-1247-B12B-A152D7403BAA}" type="datetimeFigureOut">
              <a:rPr lang="en-US" smtClean="0"/>
              <a:t>2/2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80D4A-827A-4641-B335-57EB1696B1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03132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A4233-F2BF-1247-B12B-A152D7403BAA}" type="datetimeFigureOut">
              <a:rPr lang="en-US" smtClean="0"/>
              <a:t>2/2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80D4A-827A-4641-B335-57EB1696B1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71025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A4233-F2BF-1247-B12B-A152D7403BAA}" type="datetimeFigureOut">
              <a:rPr lang="en-US" smtClean="0"/>
              <a:t>2/2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80D4A-827A-4641-B335-57EB1696B1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40651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A4233-F2BF-1247-B12B-A152D7403BAA}" type="datetimeFigureOut">
              <a:rPr lang="en-US" smtClean="0"/>
              <a:t>2/2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80D4A-827A-4641-B335-57EB1696B1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02440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A4233-F2BF-1247-B12B-A152D7403BAA}" type="datetimeFigureOut">
              <a:rPr lang="en-US" smtClean="0"/>
              <a:t>2/2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80D4A-827A-4641-B335-57EB1696B1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87886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A4233-F2BF-1247-B12B-A152D7403BAA}" type="datetimeFigureOut">
              <a:rPr lang="en-US" smtClean="0"/>
              <a:t>2/21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80D4A-827A-4641-B335-57EB1696B1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42241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A4233-F2BF-1247-B12B-A152D7403BAA}" type="datetimeFigureOut">
              <a:rPr lang="en-US" smtClean="0"/>
              <a:t>2/21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80D4A-827A-4641-B335-57EB1696B1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40109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A4233-F2BF-1247-B12B-A152D7403BAA}" type="datetimeFigureOut">
              <a:rPr lang="en-US" smtClean="0"/>
              <a:t>2/21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80D4A-827A-4641-B335-57EB1696B1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52473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A4233-F2BF-1247-B12B-A152D7403BAA}" type="datetimeFigureOut">
              <a:rPr lang="en-US" smtClean="0"/>
              <a:t>2/2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80D4A-827A-4641-B335-57EB1696B1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3342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8A4233-F2BF-1247-B12B-A152D7403BAA}" type="datetimeFigureOut">
              <a:rPr lang="en-US" smtClean="0"/>
              <a:t>2/21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E80D4A-827A-4641-B335-57EB1696B1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91097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8A4233-F2BF-1247-B12B-A152D7403BAA}" type="datetimeFigureOut">
              <a:rPr lang="en-US" smtClean="0"/>
              <a:t>2/21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E80D4A-827A-4641-B335-57EB1696B1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97546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>
            <a:extLst>
              <a:ext uri="{FF2B5EF4-FFF2-40B4-BE49-F238E27FC236}">
                <a16:creationId xmlns:a16="http://schemas.microsoft.com/office/drawing/2014/main" id="{E59AB9C5-5620-2949-993C-3A41BAA037C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40110"/>
          <a:stretch/>
        </p:blipFill>
        <p:spPr>
          <a:xfrm>
            <a:off x="98227" y="954156"/>
            <a:ext cx="9404746" cy="7510007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671F617-2E29-A443-986D-B7B7A1DD6074}"/>
              </a:ext>
            </a:extLst>
          </p:cNvPr>
          <p:cNvSpPr txBox="1"/>
          <p:nvPr/>
        </p:nvSpPr>
        <p:spPr>
          <a:xfrm>
            <a:off x="11512" y="-3576"/>
            <a:ext cx="832577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Times" pitchFamily="2" charset="0"/>
              </a:rPr>
              <a:t>Supplementary Fig. 1</a:t>
            </a:r>
          </a:p>
        </p:txBody>
      </p:sp>
    </p:spTree>
    <p:extLst>
      <p:ext uri="{BB962C8B-B14F-4D97-AF65-F5344CB8AC3E}">
        <p14:creationId xmlns:p14="http://schemas.microsoft.com/office/powerpoint/2010/main" val="37465923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BBFA9A89-C287-2840-956D-DC89EB1908C4}"/>
              </a:ext>
            </a:extLst>
          </p:cNvPr>
          <p:cNvSpPr txBox="1"/>
          <p:nvPr/>
        </p:nvSpPr>
        <p:spPr>
          <a:xfrm>
            <a:off x="11512" y="-3576"/>
            <a:ext cx="832577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Times" pitchFamily="2" charset="0"/>
              </a:rPr>
              <a:t>Supplementary Fig. 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54FC845-5437-6C4E-A0BC-DF3C30B3CF37}"/>
              </a:ext>
            </a:extLst>
          </p:cNvPr>
          <p:cNvSpPr txBox="1"/>
          <p:nvPr/>
        </p:nvSpPr>
        <p:spPr>
          <a:xfrm>
            <a:off x="2262902" y="827421"/>
            <a:ext cx="418704" cy="48000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519" dirty="0">
                <a:latin typeface="Times" pitchFamily="2" charset="0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976335F7-E80D-0B48-8ECE-F92B3D1C87F4}"/>
              </a:ext>
            </a:extLst>
          </p:cNvPr>
          <p:cNvSpPr txBox="1"/>
          <p:nvPr/>
        </p:nvSpPr>
        <p:spPr>
          <a:xfrm>
            <a:off x="2282138" y="7154846"/>
            <a:ext cx="399468" cy="48000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519" dirty="0">
                <a:latin typeface="Times" pitchFamily="2" charset="0"/>
              </a:rPr>
              <a:t>B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8CE3704F-2E3D-9B48-AE66-6C699046E8E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08720" y="704902"/>
            <a:ext cx="6026053" cy="5821349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93A79B6A-9ACB-A448-96C2-3CBF2E00281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708720" y="6792067"/>
            <a:ext cx="6026053" cy="59997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1636756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BC86288-EF78-A94F-81BE-33E5C88D5D94}"/>
              </a:ext>
            </a:extLst>
          </p:cNvPr>
          <p:cNvSpPr txBox="1"/>
          <p:nvPr/>
        </p:nvSpPr>
        <p:spPr>
          <a:xfrm>
            <a:off x="10142" y="0"/>
            <a:ext cx="5366985" cy="2862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dirty="0">
                <a:latin typeface="Times" pitchFamily="2" charset="0"/>
                <a:cs typeface="Arial" panose="020B0604020202020204" pitchFamily="34" charset="0"/>
              </a:rPr>
              <a:t>Supplementary Fig. 3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2C7A139-606F-3342-983D-CC88BA7F4F51}"/>
              </a:ext>
            </a:extLst>
          </p:cNvPr>
          <p:cNvSpPr txBox="1"/>
          <p:nvPr/>
        </p:nvSpPr>
        <p:spPr>
          <a:xfrm>
            <a:off x="10142" y="300560"/>
            <a:ext cx="294121" cy="2862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D116A66-4379-9C4B-8AEA-D70E6771EB1D}"/>
              </a:ext>
            </a:extLst>
          </p:cNvPr>
          <p:cNvSpPr txBox="1"/>
          <p:nvPr/>
        </p:nvSpPr>
        <p:spPr>
          <a:xfrm>
            <a:off x="10146" y="2450689"/>
            <a:ext cx="294121" cy="2862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C9B8EBB-0DE2-344F-8657-08BCC3DD225C}"/>
              </a:ext>
            </a:extLst>
          </p:cNvPr>
          <p:cNvSpPr txBox="1"/>
          <p:nvPr/>
        </p:nvSpPr>
        <p:spPr>
          <a:xfrm>
            <a:off x="4802483" y="300560"/>
            <a:ext cx="294121" cy="2862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6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6629DB63-FD25-46E1-81DE-89EB42C9DFE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99725172"/>
              </p:ext>
            </p:extLst>
          </p:nvPr>
        </p:nvGraphicFramePr>
        <p:xfrm>
          <a:off x="304263" y="616291"/>
          <a:ext cx="4139294" cy="1588914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484580">
                  <a:extLst>
                    <a:ext uri="{9D8B030D-6E8A-4147-A177-3AD203B41FA5}">
                      <a16:colId xmlns:a16="http://schemas.microsoft.com/office/drawing/2014/main" val="1276241398"/>
                    </a:ext>
                  </a:extLst>
                </a:gridCol>
                <a:gridCol w="448332">
                  <a:extLst>
                    <a:ext uri="{9D8B030D-6E8A-4147-A177-3AD203B41FA5}">
                      <a16:colId xmlns:a16="http://schemas.microsoft.com/office/drawing/2014/main" val="3356023427"/>
                    </a:ext>
                  </a:extLst>
                </a:gridCol>
                <a:gridCol w="718820">
                  <a:extLst>
                    <a:ext uri="{9D8B030D-6E8A-4147-A177-3AD203B41FA5}">
                      <a16:colId xmlns:a16="http://schemas.microsoft.com/office/drawing/2014/main" val="1183254659"/>
                    </a:ext>
                  </a:extLst>
                </a:gridCol>
                <a:gridCol w="810521">
                  <a:extLst>
                    <a:ext uri="{9D8B030D-6E8A-4147-A177-3AD203B41FA5}">
                      <a16:colId xmlns:a16="http://schemas.microsoft.com/office/drawing/2014/main" val="1941677047"/>
                    </a:ext>
                  </a:extLst>
                </a:gridCol>
                <a:gridCol w="765727">
                  <a:extLst>
                    <a:ext uri="{9D8B030D-6E8A-4147-A177-3AD203B41FA5}">
                      <a16:colId xmlns:a16="http://schemas.microsoft.com/office/drawing/2014/main" val="521331959"/>
                    </a:ext>
                  </a:extLst>
                </a:gridCol>
                <a:gridCol w="424998">
                  <a:extLst>
                    <a:ext uri="{9D8B030D-6E8A-4147-A177-3AD203B41FA5}">
                      <a16:colId xmlns:a16="http://schemas.microsoft.com/office/drawing/2014/main" val="927943209"/>
                    </a:ext>
                  </a:extLst>
                </a:gridCol>
                <a:gridCol w="486316">
                  <a:extLst>
                    <a:ext uri="{9D8B030D-6E8A-4147-A177-3AD203B41FA5}">
                      <a16:colId xmlns:a16="http://schemas.microsoft.com/office/drawing/2014/main" val="615561831"/>
                    </a:ext>
                  </a:extLst>
                </a:gridCol>
              </a:tblGrid>
              <a:tr h="447496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hway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FA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cosanoid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SA ≤ 3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SA &gt; 3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value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adjusted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/>
                </a:tc>
                <a:extLst>
                  <a:ext uri="{0D108BD9-81ED-4DB2-BD59-A6C34878D82A}">
                    <a16:rowId xmlns:a16="http://schemas.microsoft.com/office/drawing/2014/main" val="1942890757"/>
                  </a:ext>
                </a:extLst>
              </a:tr>
              <a:tr h="108455">
                <a:tc rowSpan="4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OX</a:t>
                      </a:r>
                    </a:p>
                  </a:txBody>
                  <a:tcPr marL="54007" marR="54007" marT="0" marB="0"/>
                </a:tc>
                <a:tc rowSpan="3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A</a:t>
                      </a:r>
                    </a:p>
                  </a:txBody>
                  <a:tcPr marL="54007" marR="54007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GE2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62 ( 1.407 )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17 ( 0.52 )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2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5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/>
                </a:tc>
                <a:extLst>
                  <a:ext uri="{0D108BD9-81ED-4DB2-BD59-A6C34878D82A}">
                    <a16:rowId xmlns:a16="http://schemas.microsoft.com/office/drawing/2014/main" val="1718786814"/>
                  </a:ext>
                </a:extLst>
              </a:tr>
              <a:tr h="222728">
                <a:tc vMerge="1">
                  <a:txBody>
                    <a:bodyPr/>
                    <a:lstStyle/>
                    <a:p>
                      <a:endParaRPr lang="en-US" sz="11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vMerge="1">
                  <a:txBody>
                    <a:bodyPr/>
                    <a:lstStyle/>
                    <a:p>
                      <a:endParaRPr lang="en-US" sz="11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,15 dk-,dh- PGF1a</a:t>
                      </a:r>
                      <a:endParaRPr lang="en-US" sz="7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98 ( 8.249 )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53 ( 3.477 )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6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97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 anchor="b"/>
                </a:tc>
                <a:extLst>
                  <a:ext uri="{0D108BD9-81ED-4DB2-BD59-A6C34878D82A}">
                    <a16:rowId xmlns:a16="http://schemas.microsoft.com/office/drawing/2014/main" val="4083319222"/>
                  </a:ext>
                </a:extLst>
              </a:tr>
              <a:tr h="216910">
                <a:tc vMerge="1">
                  <a:txBody>
                    <a:bodyPr/>
                    <a:lstStyle/>
                    <a:p>
                      <a:endParaRPr lang="en-US" sz="11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vMerge="1">
                  <a:txBody>
                    <a:bodyPr/>
                    <a:lstStyle/>
                    <a:p>
                      <a:endParaRPr lang="en-US" sz="11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tranor</a:t>
                      </a: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PGFM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5 ( 1.328 )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98 ( 4.369 )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34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7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 anchor="b"/>
                </a:tc>
                <a:extLst>
                  <a:ext uri="{0D108BD9-81ED-4DB2-BD59-A6C34878D82A}">
                    <a16:rowId xmlns:a16="http://schemas.microsoft.com/office/drawing/2014/main" val="2702062623"/>
                  </a:ext>
                </a:extLst>
              </a:tr>
              <a:tr h="114925">
                <a:tc vMerge="1">
                  <a:txBody>
                    <a:bodyPr/>
                    <a:lstStyle/>
                    <a:p>
                      <a:endParaRPr lang="en-US" sz="11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PA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XB3</a:t>
                      </a:r>
                      <a:endParaRPr lang="en-US" sz="7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68 ( 0.286 )</a:t>
                      </a:r>
                      <a:endParaRPr lang="en-US" sz="7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84 ( 0.164 )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4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2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 anchor="b"/>
                </a:tc>
                <a:extLst>
                  <a:ext uri="{0D108BD9-81ED-4DB2-BD59-A6C34878D82A}">
                    <a16:rowId xmlns:a16="http://schemas.microsoft.com/office/drawing/2014/main" val="4276535092"/>
                  </a:ext>
                </a:extLst>
              </a:tr>
              <a:tr h="109154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LOX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TB4</a:t>
                      </a:r>
                      <a:endParaRPr lang="en-US" sz="7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18 ( 0.567 )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56 ( 0.109 )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7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84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 anchor="b"/>
                </a:tc>
                <a:extLst>
                  <a:ext uri="{0D108BD9-81ED-4DB2-BD59-A6C34878D82A}">
                    <a16:rowId xmlns:a16="http://schemas.microsoft.com/office/drawing/2014/main" val="1455092286"/>
                  </a:ext>
                </a:extLst>
              </a:tr>
              <a:tr h="114925">
                <a:tc rowSpan="2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LOX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/>
                </a:tc>
                <a:tc rowSpan="2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A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-oxoETE</a:t>
                      </a:r>
                      <a:endParaRPr lang="en-US" sz="7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037 ( 8.893 )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17 ( 1.623 )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8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95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 anchor="b"/>
                </a:tc>
                <a:extLst>
                  <a:ext uri="{0D108BD9-81ED-4DB2-BD59-A6C34878D82A}">
                    <a16:rowId xmlns:a16="http://schemas.microsoft.com/office/drawing/2014/main" val="2388473347"/>
                  </a:ext>
                </a:extLst>
              </a:tr>
              <a:tr h="114925">
                <a:tc vMerge="1">
                  <a:txBody>
                    <a:bodyPr/>
                    <a:lstStyle/>
                    <a:p>
                      <a:endParaRPr lang="en-US" sz="11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 vMerge="1">
                  <a:txBody>
                    <a:bodyPr/>
                    <a:lstStyle/>
                    <a:p>
                      <a:endParaRPr lang="en-US" sz="11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XB3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966 ( 8.396 )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354 ( 5.764 )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4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 anchor="b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6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 anchor="b"/>
                </a:tc>
                <a:extLst>
                  <a:ext uri="{0D108BD9-81ED-4DB2-BD59-A6C34878D82A}">
                    <a16:rowId xmlns:a16="http://schemas.microsoft.com/office/drawing/2014/main" val="3568393611"/>
                  </a:ext>
                </a:extLst>
              </a:tr>
              <a:tr h="139396">
                <a:tc>
                  <a:txBody>
                    <a:bodyPr/>
                    <a:lstStyle/>
                    <a:p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LOX</a:t>
                      </a:r>
                    </a:p>
                  </a:txBody>
                  <a:tcPr marL="54007" marR="54007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A</a:t>
                      </a:r>
                    </a:p>
                  </a:txBody>
                  <a:tcPr marL="54007" marR="54007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,15-diHETE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05 ( 1.395 )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96 ( 0.779 )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43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7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54007" marR="54007" marT="0" marB="0"/>
                </a:tc>
                <a:extLst>
                  <a:ext uri="{0D108BD9-81ED-4DB2-BD59-A6C34878D82A}">
                    <a16:rowId xmlns:a16="http://schemas.microsoft.com/office/drawing/2014/main" val="3371812324"/>
                  </a:ext>
                </a:extLst>
              </a:tr>
            </a:tbl>
          </a:graphicData>
        </a:graphic>
      </p:graphicFrame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B2B2ADF2-69D0-4439-8386-2425B7C2763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61252953"/>
              </p:ext>
            </p:extLst>
          </p:nvPr>
        </p:nvGraphicFramePr>
        <p:xfrm>
          <a:off x="304263" y="2675765"/>
          <a:ext cx="4139294" cy="2213593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475907">
                  <a:extLst>
                    <a:ext uri="{9D8B030D-6E8A-4147-A177-3AD203B41FA5}">
                      <a16:colId xmlns:a16="http://schemas.microsoft.com/office/drawing/2014/main" val="707081437"/>
                    </a:ext>
                  </a:extLst>
                </a:gridCol>
                <a:gridCol w="464986">
                  <a:extLst>
                    <a:ext uri="{9D8B030D-6E8A-4147-A177-3AD203B41FA5}">
                      <a16:colId xmlns:a16="http://schemas.microsoft.com/office/drawing/2014/main" val="3045004361"/>
                    </a:ext>
                  </a:extLst>
                </a:gridCol>
                <a:gridCol w="714089">
                  <a:extLst>
                    <a:ext uri="{9D8B030D-6E8A-4147-A177-3AD203B41FA5}">
                      <a16:colId xmlns:a16="http://schemas.microsoft.com/office/drawing/2014/main" val="776855476"/>
                    </a:ext>
                  </a:extLst>
                </a:gridCol>
                <a:gridCol w="813102">
                  <a:extLst>
                    <a:ext uri="{9D8B030D-6E8A-4147-A177-3AD203B41FA5}">
                      <a16:colId xmlns:a16="http://schemas.microsoft.com/office/drawing/2014/main" val="1502354619"/>
                    </a:ext>
                  </a:extLst>
                </a:gridCol>
                <a:gridCol w="765096">
                  <a:extLst>
                    <a:ext uri="{9D8B030D-6E8A-4147-A177-3AD203B41FA5}">
                      <a16:colId xmlns:a16="http://schemas.microsoft.com/office/drawing/2014/main" val="1396035481"/>
                    </a:ext>
                  </a:extLst>
                </a:gridCol>
                <a:gridCol w="420053">
                  <a:extLst>
                    <a:ext uri="{9D8B030D-6E8A-4147-A177-3AD203B41FA5}">
                      <a16:colId xmlns:a16="http://schemas.microsoft.com/office/drawing/2014/main" val="3307468941"/>
                    </a:ext>
                  </a:extLst>
                </a:gridCol>
                <a:gridCol w="486061">
                  <a:extLst>
                    <a:ext uri="{9D8B030D-6E8A-4147-A177-3AD203B41FA5}">
                      <a16:colId xmlns:a16="http://schemas.microsoft.com/office/drawing/2014/main" val="3433959723"/>
                    </a:ext>
                  </a:extLst>
                </a:gridCol>
              </a:tblGrid>
              <a:tr h="254118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hway</a:t>
                      </a:r>
                      <a:endParaRPr lang="en-US" sz="7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FA</a:t>
                      </a:r>
                      <a:endParaRPr lang="en-US" sz="7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icosanoid</a:t>
                      </a:r>
                      <a:endParaRPr lang="en-US" sz="7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SA ≤ 3</a:t>
                      </a:r>
                      <a:endParaRPr lang="en-US" sz="7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SA &gt; 3</a:t>
                      </a:r>
                      <a:endParaRPr lang="en-US" sz="7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value</a:t>
                      </a:r>
                      <a:endParaRPr lang="en-US" sz="7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b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adjusted</a:t>
                      </a:r>
                      <a:endParaRPr lang="en-US" sz="700" b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extLst>
                  <a:ext uri="{0D108BD9-81ED-4DB2-BD59-A6C34878D82A}">
                    <a16:rowId xmlns:a16="http://schemas.microsoft.com/office/drawing/2014/main" val="2493932227"/>
                  </a:ext>
                </a:extLst>
              </a:tr>
              <a:tr h="159131">
                <a:tc rowSpan="3">
                  <a:txBody>
                    <a:bodyPr/>
                    <a:lstStyle/>
                    <a:p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X</a:t>
                      </a: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A</a:t>
                      </a: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-HETE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543 ( 10.375 )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16 ( 2.252 )</a:t>
                      </a:r>
                      <a:endParaRPr lang="en-US" sz="7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09</a:t>
                      </a:r>
                      <a:endParaRPr lang="en-US" sz="7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3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extLst>
                  <a:ext uri="{0D108BD9-81ED-4DB2-BD59-A6C34878D82A}">
                    <a16:rowId xmlns:a16="http://schemas.microsoft.com/office/drawing/2014/main" val="3461954153"/>
                  </a:ext>
                </a:extLst>
              </a:tr>
              <a:tr h="159131">
                <a:tc vMerge="1">
                  <a:txBody>
                    <a:bodyPr/>
                    <a:lstStyle/>
                    <a:p>
                      <a:endParaRPr lang="en-US" sz="800" dirty="0">
                        <a:effectLst/>
                        <a:latin typeface="+mj-lt"/>
                        <a:cs typeface="Times New Roman" panose="02020603050405020304" pitchFamily="18" charset="0"/>
                      </a:endParaRPr>
                    </a:p>
                  </a:txBody>
                  <a:tcPr marL="29696" marR="29696" marT="0" marB="0"/>
                </a:tc>
                <a:tc rowSpan="2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PA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-HEPE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842 ( 6.113 )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63 ( 2.054 )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</a:t>
                      </a:r>
                      <a:endParaRPr lang="en-US" sz="7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61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extLst>
                  <a:ext uri="{0D108BD9-81ED-4DB2-BD59-A6C34878D82A}">
                    <a16:rowId xmlns:a16="http://schemas.microsoft.com/office/drawing/2014/main" val="1920028799"/>
                  </a:ext>
                </a:extLst>
              </a:tr>
              <a:tr h="159131">
                <a:tc vMerge="1">
                  <a:txBody>
                    <a:bodyPr/>
                    <a:lstStyle/>
                    <a:p>
                      <a:endParaRPr lang="en-US" sz="800" dirty="0">
                        <a:effectLst/>
                        <a:latin typeface="+mj-lt"/>
                        <a:cs typeface="Times New Roman" panose="02020603050405020304" pitchFamily="18" charset="0"/>
                      </a:endParaRPr>
                    </a:p>
                  </a:txBody>
                  <a:tcPr marL="29696" marR="29696" marT="0" marB="0"/>
                </a:tc>
                <a:tc vMerge="1">
                  <a:txBody>
                    <a:bodyPr/>
                    <a:lstStyle/>
                    <a:p>
                      <a:endParaRPr lang="en-US" sz="800" dirty="0">
                        <a:effectLst/>
                        <a:latin typeface="+mj-lt"/>
                        <a:cs typeface="Times New Roman" panose="02020603050405020304" pitchFamily="18" charset="0"/>
                      </a:endParaRPr>
                    </a:p>
                  </a:txBody>
                  <a:tcPr marL="29696" marR="2969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-HEPE</a:t>
                      </a:r>
                      <a:endParaRPr lang="en-US" sz="7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06 ( 1.274 )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38 ( 0.469 )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4</a:t>
                      </a:r>
                      <a:endParaRPr lang="en-US" sz="7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4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extLst>
                  <a:ext uri="{0D108BD9-81ED-4DB2-BD59-A6C34878D82A}">
                    <a16:rowId xmlns:a16="http://schemas.microsoft.com/office/drawing/2014/main" val="1814212502"/>
                  </a:ext>
                </a:extLst>
              </a:tr>
              <a:tr h="159131">
                <a:tc>
                  <a:txBody>
                    <a:bodyPr/>
                    <a:lstStyle/>
                    <a:p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LOX</a:t>
                      </a: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HA</a:t>
                      </a: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 HDoHE</a:t>
                      </a:r>
                      <a:endParaRPr lang="en-US" sz="7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695 ( 5.169 )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19 ( 1.647 )</a:t>
                      </a:r>
                      <a:endParaRPr lang="en-US" sz="7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5</a:t>
                      </a:r>
                      <a:endParaRPr lang="en-US" sz="7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67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extLst>
                  <a:ext uri="{0D108BD9-81ED-4DB2-BD59-A6C34878D82A}">
                    <a16:rowId xmlns:a16="http://schemas.microsoft.com/office/drawing/2014/main" val="735470833"/>
                  </a:ext>
                </a:extLst>
              </a:tr>
              <a:tr h="159131">
                <a:tc rowSpan="3">
                  <a:txBody>
                    <a:bodyPr/>
                    <a:lstStyle/>
                    <a:p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LOX</a:t>
                      </a: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A</a:t>
                      </a: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-HEPE</a:t>
                      </a:r>
                      <a:endParaRPr lang="en-US" sz="7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.11 ( 53.997 )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723 ( 20.974 )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8</a:t>
                      </a:r>
                      <a:endParaRPr lang="en-US" sz="7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9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extLst>
                  <a:ext uri="{0D108BD9-81ED-4DB2-BD59-A6C34878D82A}">
                    <a16:rowId xmlns:a16="http://schemas.microsoft.com/office/drawing/2014/main" val="2030686744"/>
                  </a:ext>
                </a:extLst>
              </a:tr>
              <a:tr h="159131">
                <a:tc vMerge="1">
                  <a:txBody>
                    <a:bodyPr/>
                    <a:lstStyle/>
                    <a:p>
                      <a:endParaRPr lang="en-US" sz="800" dirty="0">
                        <a:effectLst/>
                        <a:latin typeface="+mj-lt"/>
                        <a:cs typeface="Times New Roman" panose="02020603050405020304" pitchFamily="18" charset="0"/>
                      </a:endParaRPr>
                    </a:p>
                  </a:txBody>
                  <a:tcPr marL="29696" marR="29696" marT="0" marB="0"/>
                </a:tc>
                <a:tc rowSpan="2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HA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 HDoHE</a:t>
                      </a:r>
                      <a:endParaRPr lang="en-US" sz="7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857 ( 11.494 )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54 ( 3.863 )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2</a:t>
                      </a:r>
                      <a:endParaRPr lang="en-US" sz="7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84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extLst>
                  <a:ext uri="{0D108BD9-81ED-4DB2-BD59-A6C34878D82A}">
                    <a16:rowId xmlns:a16="http://schemas.microsoft.com/office/drawing/2014/main" val="2816236387"/>
                  </a:ext>
                </a:extLst>
              </a:tr>
              <a:tr h="203255">
                <a:tc vMerge="1">
                  <a:txBody>
                    <a:bodyPr/>
                    <a:lstStyle/>
                    <a:p>
                      <a:endParaRPr lang="en-US" sz="800" dirty="0">
                        <a:effectLst/>
                        <a:latin typeface="+mj-lt"/>
                        <a:cs typeface="Times New Roman" panose="02020603050405020304" pitchFamily="18" charset="0"/>
                      </a:endParaRPr>
                    </a:p>
                  </a:txBody>
                  <a:tcPr marL="29696" marR="29696" marT="0" marB="0"/>
                </a:tc>
                <a:tc vMerge="1">
                  <a:txBody>
                    <a:bodyPr/>
                    <a:lstStyle/>
                    <a:p>
                      <a:endParaRPr lang="en-US" sz="800" dirty="0">
                        <a:effectLst/>
                        <a:latin typeface="+mj-lt"/>
                        <a:cs typeface="Times New Roman" panose="02020603050405020304" pitchFamily="18" charset="0"/>
                      </a:endParaRPr>
                    </a:p>
                  </a:txBody>
                  <a:tcPr marL="29696" marR="2969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 HDoHE</a:t>
                      </a:r>
                      <a:endParaRPr lang="en-US" sz="7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0.105 ( 195.2 )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3.231 ( 75.08 )</a:t>
                      </a:r>
                      <a:endParaRPr lang="en-US" sz="7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4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88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extLst>
                  <a:ext uri="{0D108BD9-81ED-4DB2-BD59-A6C34878D82A}">
                    <a16:rowId xmlns:a16="http://schemas.microsoft.com/office/drawing/2014/main" val="1125445639"/>
                  </a:ext>
                </a:extLst>
              </a:tr>
              <a:tr h="159131">
                <a:tc>
                  <a:txBody>
                    <a:bodyPr/>
                    <a:lstStyle/>
                    <a:p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LOX</a:t>
                      </a: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PA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-HEPE</a:t>
                      </a:r>
                      <a:endParaRPr lang="en-US" sz="7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05 ( 1.83 )</a:t>
                      </a:r>
                      <a:endParaRPr lang="en-US" sz="7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13 ( 0.549 )</a:t>
                      </a:r>
                      <a:endParaRPr lang="en-US" sz="7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5</a:t>
                      </a:r>
                      <a:endParaRPr lang="en-US" sz="7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1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extLst>
                  <a:ext uri="{0D108BD9-81ED-4DB2-BD59-A6C34878D82A}">
                    <a16:rowId xmlns:a16="http://schemas.microsoft.com/office/drawing/2014/main" val="3215118156"/>
                  </a:ext>
                </a:extLst>
              </a:tr>
              <a:tr h="159131">
                <a:tc rowSpan="2">
                  <a:txBody>
                    <a:bodyPr/>
                    <a:lstStyle/>
                    <a:p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P</a:t>
                      </a: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A</a:t>
                      </a: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,9-diHETrE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46 ( 1.684 )</a:t>
                      </a:r>
                      <a:endParaRPr lang="en-US" sz="7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54 ( 0.824 )</a:t>
                      </a:r>
                      <a:endParaRPr lang="en-US" sz="7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3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7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extLst>
                  <a:ext uri="{0D108BD9-81ED-4DB2-BD59-A6C34878D82A}">
                    <a16:rowId xmlns:a16="http://schemas.microsoft.com/office/drawing/2014/main" val="1649729496"/>
                  </a:ext>
                </a:extLst>
              </a:tr>
              <a:tr h="159131">
                <a:tc vMerge="1">
                  <a:txBody>
                    <a:bodyPr/>
                    <a:lstStyle/>
                    <a:p>
                      <a:endParaRPr lang="en-US" sz="800" dirty="0">
                        <a:effectLst/>
                        <a:latin typeface="+mj-lt"/>
                        <a:cs typeface="Times New Roman" panose="02020603050405020304" pitchFamily="18" charset="0"/>
                      </a:endParaRPr>
                    </a:p>
                  </a:txBody>
                  <a:tcPr marL="29696" marR="2969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HA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,17 dHDPA</a:t>
                      </a:r>
                      <a:endParaRPr lang="en-US" sz="7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57 ( 0.796 )</a:t>
                      </a:r>
                      <a:endParaRPr lang="en-US" sz="7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36 ( 0.756 )</a:t>
                      </a:r>
                      <a:endParaRPr lang="en-US" sz="7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61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4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extLst>
                  <a:ext uri="{0D108BD9-81ED-4DB2-BD59-A6C34878D82A}">
                    <a16:rowId xmlns:a16="http://schemas.microsoft.com/office/drawing/2014/main" val="3562130282"/>
                  </a:ext>
                </a:extLst>
              </a:tr>
              <a:tr h="159131">
                <a:tc rowSpan="2">
                  <a:txBody>
                    <a:bodyPr/>
                    <a:lstStyle/>
                    <a:p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-enzymatic</a:t>
                      </a: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PA</a:t>
                      </a: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-HEPE</a:t>
                      </a:r>
                      <a:endParaRPr lang="en-US" sz="7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79 ( 0.917 )</a:t>
                      </a:r>
                      <a:endParaRPr lang="en-US" sz="7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58 ( 0.446 )</a:t>
                      </a:r>
                      <a:endParaRPr lang="en-US" sz="7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7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6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extLst>
                  <a:ext uri="{0D108BD9-81ED-4DB2-BD59-A6C34878D82A}">
                    <a16:rowId xmlns:a16="http://schemas.microsoft.com/office/drawing/2014/main" val="4103160547"/>
                  </a:ext>
                </a:extLst>
              </a:tr>
              <a:tr h="164910">
                <a:tc vMerge="1">
                  <a:txBody>
                    <a:bodyPr/>
                    <a:lstStyle/>
                    <a:p>
                      <a:endParaRPr lang="en-US" sz="800" dirty="0">
                        <a:effectLst/>
                        <a:latin typeface="+mj-lt"/>
                        <a:cs typeface="Times New Roman" panose="02020603050405020304" pitchFamily="18" charset="0"/>
                      </a:endParaRPr>
                    </a:p>
                  </a:txBody>
                  <a:tcPr marL="29696" marR="29696" marT="0" marB="0"/>
                </a:tc>
                <a:tc>
                  <a:txBody>
                    <a:bodyPr/>
                    <a:lstStyle/>
                    <a:p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HA</a:t>
                      </a: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 HDoHE</a:t>
                      </a:r>
                      <a:endParaRPr lang="en-US" sz="7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744 ( 3.591 )</a:t>
                      </a:r>
                      <a:endParaRPr lang="en-US" sz="7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21 ( 1.478 )</a:t>
                      </a:r>
                      <a:endParaRPr lang="en-US" sz="7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2</a:t>
                      </a:r>
                      <a:endParaRPr lang="en-US" sz="7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7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91</a:t>
                      </a:r>
                      <a:endParaRPr lang="en-US" sz="7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3386" marR="23386" marT="0" marB="0"/>
                </a:tc>
                <a:extLst>
                  <a:ext uri="{0D108BD9-81ED-4DB2-BD59-A6C34878D82A}">
                    <a16:rowId xmlns:a16="http://schemas.microsoft.com/office/drawing/2014/main" val="2116068368"/>
                  </a:ext>
                </a:extLst>
              </a:tr>
            </a:tbl>
          </a:graphicData>
        </a:graphic>
      </p:graphicFrame>
      <p:pic>
        <p:nvPicPr>
          <p:cNvPr id="10" name="Picture 9">
            <a:extLst>
              <a:ext uri="{FF2B5EF4-FFF2-40B4-BE49-F238E27FC236}">
                <a16:creationId xmlns:a16="http://schemas.microsoft.com/office/drawing/2014/main" id="{46AC70B6-37FF-2643-8B58-9B496A0F77C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46795" y="883782"/>
            <a:ext cx="4430554" cy="34004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6659291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097</TotalTime>
  <Words>302</Words>
  <Application>Microsoft Macintosh PowerPoint</Application>
  <PresentationFormat>A3 Paper (297x420 mm)</PresentationFormat>
  <Paragraphs>149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ras, Roxana</dc:creator>
  <cp:lastModifiedBy>Coras, Roxana</cp:lastModifiedBy>
  <cp:revision>112</cp:revision>
  <dcterms:created xsi:type="dcterms:W3CDTF">2020-06-02T20:09:43Z</dcterms:created>
  <dcterms:modified xsi:type="dcterms:W3CDTF">2021-02-21T19:01:40Z</dcterms:modified>
</cp:coreProperties>
</file>